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5400675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652" y="-36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1296173"/>
            <a:ext cx="4590574" cy="2757347"/>
          </a:xfrm>
        </p:spPr>
        <p:txBody>
          <a:bodyPr anchor="b"/>
          <a:lstStyle>
            <a:lvl1pPr algn="ctr">
              <a:defRPr sz="354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4159854"/>
            <a:ext cx="4050506" cy="1912175"/>
          </a:xfrm>
        </p:spPr>
        <p:txBody>
          <a:bodyPr/>
          <a:lstStyle>
            <a:lvl1pPr marL="0" indent="0" algn="ctr">
              <a:buNone/>
              <a:defRPr sz="1417"/>
            </a:lvl1pPr>
            <a:lvl2pPr marL="270022" indent="0" algn="ctr">
              <a:buNone/>
              <a:defRPr sz="1181"/>
            </a:lvl2pPr>
            <a:lvl3pPr marL="540045" indent="0" algn="ctr">
              <a:buNone/>
              <a:defRPr sz="1063"/>
            </a:lvl3pPr>
            <a:lvl4pPr marL="810067" indent="0" algn="ctr">
              <a:buNone/>
              <a:defRPr sz="945"/>
            </a:lvl4pPr>
            <a:lvl5pPr marL="1080089" indent="0" algn="ctr">
              <a:buNone/>
              <a:defRPr sz="945"/>
            </a:lvl5pPr>
            <a:lvl6pPr marL="1350112" indent="0" algn="ctr">
              <a:buNone/>
              <a:defRPr sz="945"/>
            </a:lvl6pPr>
            <a:lvl7pPr marL="1620134" indent="0" algn="ctr">
              <a:buNone/>
              <a:defRPr sz="945"/>
            </a:lvl7pPr>
            <a:lvl8pPr marL="1890156" indent="0" algn="ctr">
              <a:buNone/>
              <a:defRPr sz="945"/>
            </a:lvl8pPr>
            <a:lvl9pPr marL="2160179" indent="0" algn="ctr">
              <a:buNone/>
              <a:defRPr sz="945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2209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9526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421669"/>
            <a:ext cx="1164521" cy="671186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421669"/>
            <a:ext cx="3426053" cy="671186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7131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65510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1974512"/>
            <a:ext cx="4658082" cy="3294515"/>
          </a:xfrm>
        </p:spPr>
        <p:txBody>
          <a:bodyPr anchor="b"/>
          <a:lstStyle>
            <a:lvl1pPr>
              <a:defRPr sz="354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5300194"/>
            <a:ext cx="4658082" cy="1732508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/>
                </a:solidFill>
              </a:defRPr>
            </a:lvl1pPr>
            <a:lvl2pPr marL="270022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40045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10067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8008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50112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20134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9015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6017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9962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2108344"/>
            <a:ext cx="2295287" cy="502519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2108344"/>
            <a:ext cx="2295287" cy="502519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9590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421671"/>
            <a:ext cx="4658082" cy="153084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1941510"/>
            <a:ext cx="2284738" cy="951504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2893014"/>
            <a:ext cx="2284738" cy="42551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1941510"/>
            <a:ext cx="2295990" cy="951504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2893014"/>
            <a:ext cx="2295990" cy="42551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43213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9647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8866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528002"/>
            <a:ext cx="1741858" cy="1848009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1140341"/>
            <a:ext cx="2734092" cy="5628360"/>
          </a:xfrm>
        </p:spPr>
        <p:txBody>
          <a:bodyPr/>
          <a:lstStyle>
            <a:lvl1pPr>
              <a:defRPr sz="1890"/>
            </a:lvl1pPr>
            <a:lvl2pPr>
              <a:defRPr sz="1654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2376011"/>
            <a:ext cx="1741858" cy="4401855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3735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528002"/>
            <a:ext cx="1741858" cy="1848009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1140341"/>
            <a:ext cx="2734092" cy="5628360"/>
          </a:xfrm>
        </p:spPr>
        <p:txBody>
          <a:bodyPr anchor="t"/>
          <a:lstStyle>
            <a:lvl1pPr marL="0" indent="0">
              <a:buNone/>
              <a:defRPr sz="1890"/>
            </a:lvl1pPr>
            <a:lvl2pPr marL="270022" indent="0">
              <a:buNone/>
              <a:defRPr sz="1654"/>
            </a:lvl2pPr>
            <a:lvl3pPr marL="540045" indent="0">
              <a:buNone/>
              <a:defRPr sz="1417"/>
            </a:lvl3pPr>
            <a:lvl4pPr marL="810067" indent="0">
              <a:buNone/>
              <a:defRPr sz="1181"/>
            </a:lvl4pPr>
            <a:lvl5pPr marL="1080089" indent="0">
              <a:buNone/>
              <a:defRPr sz="1181"/>
            </a:lvl5pPr>
            <a:lvl6pPr marL="1350112" indent="0">
              <a:buNone/>
              <a:defRPr sz="1181"/>
            </a:lvl6pPr>
            <a:lvl7pPr marL="1620134" indent="0">
              <a:buNone/>
              <a:defRPr sz="1181"/>
            </a:lvl7pPr>
            <a:lvl8pPr marL="1890156" indent="0">
              <a:buNone/>
              <a:defRPr sz="1181"/>
            </a:lvl8pPr>
            <a:lvl9pPr marL="2160179" indent="0">
              <a:buNone/>
              <a:defRPr sz="1181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2376011"/>
            <a:ext cx="1741858" cy="4401855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5838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421671"/>
            <a:ext cx="4658082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2108344"/>
            <a:ext cx="4658082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7340703"/>
            <a:ext cx="1215152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7A7E6-AEB1-4F79-AD88-8EAEC5C372EB}" type="datetimeFigureOut">
              <a:rPr lang="es-ES" smtClean="0"/>
              <a:t>13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7340703"/>
            <a:ext cx="182272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7340703"/>
            <a:ext cx="1215152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8DD48-2178-4AAF-979A-12D8604070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9913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40045" rtl="0" eaLnBrk="1" latinLnBrk="0" hangingPunct="1">
        <a:lnSpc>
          <a:spcPct val="90000"/>
        </a:lnSpc>
        <a:spcBef>
          <a:spcPct val="0"/>
        </a:spcBef>
        <a:buNone/>
        <a:defRPr sz="2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5011" indent="-135011" algn="l" defTabSz="540045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0503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5056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5078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510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512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5145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5167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519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70022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40045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10067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80089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50112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20134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90156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60179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tabla, nieve, montón, foto&#10;&#10;Descripción generada automáticamente">
            <a:extLst>
              <a:ext uri="{FF2B5EF4-FFF2-40B4-BE49-F238E27FC236}">
                <a16:creationId xmlns:a16="http://schemas.microsoft.com/office/drawing/2014/main" id="{65965009-1D53-4340-9C70-CD3026B4F6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963" y="123572"/>
            <a:ext cx="3712048" cy="5253491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646F212A-D2B8-4D72-AE25-0B9EF21F48DF}"/>
              </a:ext>
            </a:extLst>
          </p:cNvPr>
          <p:cNvSpPr txBox="1"/>
          <p:nvPr/>
        </p:nvSpPr>
        <p:spPr>
          <a:xfrm>
            <a:off x="485040" y="5377063"/>
            <a:ext cx="4556362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gure 1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NA-seq transcript validation of DEGs. Bars diagram indicates a relative TMMs from RNA-seq analysis and red line was the relative transcript gene level from RT-PCR. Figure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DREB1D (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18033409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DREB1B (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18049462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DH (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18039477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WCOR413 (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18035610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5CS (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18044634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5CDH (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18045924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NCED (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18046011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P2C (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18043434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Samples were measured in the leaves of the CAR and MAC plants grafted under cold (1°C) and control conditions for 0, 15 and 30 days. The values are the </a:t>
            </a: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s±SE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ree biological replicates (n=3) and three technical replicates per biological sample. The treatment effect tested by multi-way ANOVA, different letters indicate significant differences (P &lt; 0.05) according LSD.</a:t>
            </a:r>
            <a:endParaRPr lang="es-ES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2895442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</TotalTime>
  <Words>164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Amparo Primo Capella</dc:creator>
  <cp:lastModifiedBy>María Amparo Primo Capella</cp:lastModifiedBy>
  <cp:revision>9</cp:revision>
  <dcterms:created xsi:type="dcterms:W3CDTF">2021-04-13T08:23:04Z</dcterms:created>
  <dcterms:modified xsi:type="dcterms:W3CDTF">2021-04-13T12:55:29Z</dcterms:modified>
</cp:coreProperties>
</file>